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272" r:id="rId2"/>
    <p:sldId id="273" r:id="rId3"/>
    <p:sldId id="260" r:id="rId4"/>
    <p:sldId id="274" r:id="rId5"/>
    <p:sldId id="276" r:id="rId6"/>
    <p:sldId id="275" r:id="rId7"/>
    <p:sldId id="277" r:id="rId8"/>
    <p:sldId id="278" r:id="rId9"/>
    <p:sldId id="279" r:id="rId10"/>
    <p:sldId id="280" r:id="rId11"/>
    <p:sldId id="281" r:id="rId1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3740" autoAdjust="0"/>
  </p:normalViewPr>
  <p:slideViewPr>
    <p:cSldViewPr snapToGrid="0">
      <p:cViewPr varScale="1">
        <p:scale>
          <a:sx n="64" d="100"/>
          <a:sy n="64" d="100"/>
        </p:scale>
        <p:origin x="150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085870516185477"/>
          <c:y val="2.5428331875182269E-2"/>
          <c:w val="0.86336351706036751"/>
          <c:h val="0.79769320501603969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J$20:$J$30</c:f>
              <c:strCache>
                <c:ptCount val="11"/>
                <c:pt idx="0">
                  <c:v>5.404143636</c:v>
                </c:pt>
                <c:pt idx="1">
                  <c:v>2.530247269</c:v>
                </c:pt>
                <c:pt idx="2">
                  <c:v>1.07303166</c:v>
                </c:pt>
                <c:pt idx="3">
                  <c:v>1.756821702</c:v>
                </c:pt>
                <c:pt idx="4">
                  <c:v>0.398472121</c:v>
                </c:pt>
                <c:pt idx="5">
                  <c:v>1.663624561</c:v>
                </c:pt>
                <c:pt idx="6">
                  <c:v>3.671265328</c:v>
                </c:pt>
                <c:pt idx="7">
                  <c:v>3.810207406</c:v>
                </c:pt>
                <c:pt idx="8">
                  <c:v>3.574426268</c:v>
                </c:pt>
                <c:pt idx="9">
                  <c:v>2.362508225</c:v>
                </c:pt>
                <c:pt idx="10">
                  <c:v>3.3101577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8.5950389396525481E-2"/>
                  <c:y val="8.2341002353529424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1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</c:trendlineLbl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layout>
                <c:manualLayout>
                  <c:x val="0.12425371815249188"/>
                  <c:y val="0.19158992942099951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1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Sheet1!$J$20:$J$30</c:f>
              <c:numCache>
                <c:formatCode>General</c:formatCode>
                <c:ptCount val="11"/>
                <c:pt idx="0">
                  <c:v>5.4041436359494197</c:v>
                </c:pt>
                <c:pt idx="1">
                  <c:v>2.5302472693287998</c:v>
                </c:pt>
                <c:pt idx="2">
                  <c:v>1.0730316597899301</c:v>
                </c:pt>
                <c:pt idx="3">
                  <c:v>1.7568217020250403</c:v>
                </c:pt>
                <c:pt idx="4">
                  <c:v>0.39847212073153154</c:v>
                </c:pt>
                <c:pt idx="5">
                  <c:v>1.6636245606919708</c:v>
                </c:pt>
                <c:pt idx="6">
                  <c:v>3.6712653280893601</c:v>
                </c:pt>
                <c:pt idx="7">
                  <c:v>3.8102074060418598</c:v>
                </c:pt>
                <c:pt idx="8">
                  <c:v>3.57442626778198</c:v>
                </c:pt>
                <c:pt idx="9">
                  <c:v>2.3625082247747522</c:v>
                </c:pt>
                <c:pt idx="10">
                  <c:v>3.31015771032915</c:v>
                </c:pt>
              </c:numCache>
            </c:numRef>
          </c:xVal>
          <c:yVal>
            <c:numRef>
              <c:f>Sheet1!$I$20:$I$30</c:f>
              <c:numCache>
                <c:formatCode>General</c:formatCode>
                <c:ptCount val="11"/>
                <c:pt idx="0">
                  <c:v>6.9525480675496301</c:v>
                </c:pt>
                <c:pt idx="1">
                  <c:v>2.4221953801875959</c:v>
                </c:pt>
                <c:pt idx="2">
                  <c:v>1.4078669655615421</c:v>
                </c:pt>
                <c:pt idx="3">
                  <c:v>1.5421930219417121</c:v>
                </c:pt>
                <c:pt idx="4">
                  <c:v>0.67280062321141265</c:v>
                </c:pt>
                <c:pt idx="5">
                  <c:v>2.9129032155435439</c:v>
                </c:pt>
                <c:pt idx="6">
                  <c:v>2.7993737526093638</c:v>
                </c:pt>
                <c:pt idx="7">
                  <c:v>2.986915832141154</c:v>
                </c:pt>
                <c:pt idx="8">
                  <c:v>4.6148405737087783</c:v>
                </c:pt>
                <c:pt idx="9">
                  <c:v>2.8697317737857992</c:v>
                </c:pt>
                <c:pt idx="10">
                  <c:v>2.0274802756060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1E3-48A6-A8D1-5E606BBC68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9689424"/>
        <c:axId val="539695000"/>
      </c:scatterChart>
      <c:valAx>
        <c:axId val="53968942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ld change values from</a:t>
                </a:r>
                <a:r>
                  <a:rPr lang="en-CA" sz="1200" b="1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CA" sz="1200" b="1" baseline="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qRT</a:t>
                </a:r>
                <a:r>
                  <a:rPr lang="en-CA" sz="1200" b="1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PCR</a:t>
                </a:r>
                <a:endParaRPr lang="en-CA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32307401365522"/>
              <c:y val="0.9423394700728103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39695000"/>
        <c:crosses val="autoZero"/>
        <c:crossBetween val="midCat"/>
      </c:valAx>
      <c:valAx>
        <c:axId val="5396950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CA" sz="12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ld change values from RNAseq data</a:t>
                </a:r>
              </a:p>
            </c:rich>
          </c:tx>
          <c:layout>
            <c:manualLayout>
              <c:xMode val="edge"/>
              <c:yMode val="edge"/>
              <c:x val="1.3504548136316069E-2"/>
              <c:y val="0.132947664548803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3968942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B8C6E5-BE2B-4678-9176-5258D0085CFA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8C3790-3EE1-43AE-B32D-2D11503564E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991760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8C3790-3EE1-43AE-B32D-2D11503564EF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93185372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8C3790-3EE1-43AE-B32D-2D11503564EF}" type="slidenum">
              <a:rPr lang="en-CA" smtClean="0"/>
              <a:t>10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5750819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8C3790-3EE1-43AE-B32D-2D11503564EF}" type="slidenum">
              <a:rPr lang="en-CA" smtClean="0"/>
              <a:t>2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4503337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8C3790-3EE1-43AE-B32D-2D11503564EF}" type="slidenum">
              <a:rPr lang="en-CA" smtClean="0"/>
              <a:t>3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4617739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8C3790-3EE1-43AE-B32D-2D11503564EF}" type="slidenum">
              <a:rPr lang="en-CA" smtClean="0"/>
              <a:t>4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0732601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8C3790-3EE1-43AE-B32D-2D11503564EF}" type="slidenum">
              <a:rPr lang="en-CA" smtClean="0"/>
              <a:t>5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7636067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8C3790-3EE1-43AE-B32D-2D11503564EF}" type="slidenum">
              <a:rPr lang="en-CA" smtClean="0"/>
              <a:t>6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3913267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8C3790-3EE1-43AE-B32D-2D11503564EF}" type="slidenum">
              <a:rPr lang="en-CA" smtClean="0"/>
              <a:t>7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9216125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8C3790-3EE1-43AE-B32D-2D11503564EF}" type="slidenum">
              <a:rPr lang="en-CA" smtClean="0"/>
              <a:t>8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3598284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8C3790-3EE1-43AE-B32D-2D11503564EF}" type="slidenum">
              <a:rPr lang="en-CA" smtClean="0"/>
              <a:t>9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934749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2027B-1EC1-4F4D-8BBA-F3FFC0B3CFCF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E9107-5C98-4F3B-BABB-CE2118B9A34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6669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2027B-1EC1-4F4D-8BBA-F3FFC0B3CFCF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E9107-5C98-4F3B-BABB-CE2118B9A34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405367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2027B-1EC1-4F4D-8BBA-F3FFC0B3CFCF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E9107-5C98-4F3B-BABB-CE2118B9A34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921948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2027B-1EC1-4F4D-8BBA-F3FFC0B3CFCF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E9107-5C98-4F3B-BABB-CE2118B9A34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30155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2027B-1EC1-4F4D-8BBA-F3FFC0B3CFCF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E9107-5C98-4F3B-BABB-CE2118B9A34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90575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2027B-1EC1-4F4D-8BBA-F3FFC0B3CFCF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E9107-5C98-4F3B-BABB-CE2118B9A34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17689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2027B-1EC1-4F4D-8BBA-F3FFC0B3CFCF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E9107-5C98-4F3B-BABB-CE2118B9A34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23062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2027B-1EC1-4F4D-8BBA-F3FFC0B3CFCF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E9107-5C98-4F3B-BABB-CE2118B9A34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58233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2027B-1EC1-4F4D-8BBA-F3FFC0B3CFCF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E9107-5C98-4F3B-BABB-CE2118B9A34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54102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2027B-1EC1-4F4D-8BBA-F3FFC0B3CFCF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E9107-5C98-4F3B-BABB-CE2118B9A34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20987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2027B-1EC1-4F4D-8BBA-F3FFC0B3CFCF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E9107-5C98-4F3B-BABB-CE2118B9A34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27786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2027B-1EC1-4F4D-8BBA-F3FFC0B3CFCF}" type="datetimeFigureOut">
              <a:rPr lang="en-CA" smtClean="0"/>
              <a:t>2020-09-0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EE9107-5C98-4F3B-BABB-CE2118B9A34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44757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296399"/>
            <a:ext cx="4587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/>
              <a:t>(A)</a:t>
            </a:r>
          </a:p>
        </p:txBody>
      </p:sp>
      <p:sp>
        <p:nvSpPr>
          <p:cNvPr id="46" name="Rectangle 45"/>
          <p:cNvSpPr/>
          <p:nvPr/>
        </p:nvSpPr>
        <p:spPr>
          <a:xfrm>
            <a:off x="0" y="2908505"/>
            <a:ext cx="4507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/>
              <a:t>(B)</a:t>
            </a:r>
          </a:p>
        </p:txBody>
      </p:sp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3"/>
          <a:srcRect b="2508"/>
          <a:stretch/>
        </p:blipFill>
        <p:spPr>
          <a:xfrm>
            <a:off x="4734969" y="481065"/>
            <a:ext cx="4409031" cy="527633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8780" y="772082"/>
            <a:ext cx="4509304" cy="5282729"/>
          </a:xfrm>
          <a:prstGeom prst="rect">
            <a:avLst/>
          </a:prstGeom>
        </p:spPr>
      </p:pic>
      <p:sp>
        <p:nvSpPr>
          <p:cNvPr id="48" name="Rectangle 47"/>
          <p:cNvSpPr/>
          <p:nvPr/>
        </p:nvSpPr>
        <p:spPr>
          <a:xfrm>
            <a:off x="4713254" y="296399"/>
            <a:ext cx="4491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/>
              <a:t>(C)</a:t>
            </a:r>
            <a:endParaRPr lang="en-CA" dirty="0"/>
          </a:p>
        </p:txBody>
      </p:sp>
      <p:sp>
        <p:nvSpPr>
          <p:cNvPr id="4" name="Rectangle 3"/>
          <p:cNvSpPr/>
          <p:nvPr/>
        </p:nvSpPr>
        <p:spPr>
          <a:xfrm>
            <a:off x="57867" y="6336268"/>
            <a:ext cx="7857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/>
              <a:t>Fig. S1</a:t>
            </a:r>
          </a:p>
        </p:txBody>
      </p:sp>
    </p:spTree>
    <p:extLst>
      <p:ext uri="{BB962C8B-B14F-4D97-AF65-F5344CB8AC3E}">
        <p14:creationId xmlns:p14="http://schemas.microsoft.com/office/powerpoint/2010/main" val="8657290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4" t="8497" r="2496" b="1989"/>
          <a:stretch/>
        </p:blipFill>
        <p:spPr>
          <a:xfrm>
            <a:off x="909223" y="309544"/>
            <a:ext cx="7825945" cy="5772451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0" y="6374985"/>
            <a:ext cx="9092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>
              <a:defRPr/>
            </a:pPr>
            <a:r>
              <a:rPr lang="en-CA" dirty="0"/>
              <a:t>Fig. S4C</a:t>
            </a:r>
          </a:p>
        </p:txBody>
      </p:sp>
    </p:spTree>
    <p:extLst>
      <p:ext uri="{BB962C8B-B14F-4D97-AF65-F5344CB8AC3E}">
        <p14:creationId xmlns:p14="http://schemas.microsoft.com/office/powerpoint/2010/main" val="7153597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5875021"/>
              </p:ext>
            </p:extLst>
          </p:nvPr>
        </p:nvGraphicFramePr>
        <p:xfrm>
          <a:off x="1591194" y="2040083"/>
          <a:ext cx="5827222" cy="3719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/>
          <p:cNvSpPr/>
          <p:nvPr/>
        </p:nvSpPr>
        <p:spPr>
          <a:xfrm>
            <a:off x="0" y="6279118"/>
            <a:ext cx="7857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>
              <a:defRPr/>
            </a:pPr>
            <a:r>
              <a:rPr lang="en-CA" dirty="0"/>
              <a:t>Fig. S5</a:t>
            </a:r>
          </a:p>
        </p:txBody>
      </p:sp>
    </p:spTree>
    <p:extLst>
      <p:ext uri="{BB962C8B-B14F-4D97-AF65-F5344CB8AC3E}">
        <p14:creationId xmlns:p14="http://schemas.microsoft.com/office/powerpoint/2010/main" val="33046407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0" t="8288" r="2789" b="1649"/>
          <a:stretch/>
        </p:blipFill>
        <p:spPr>
          <a:xfrm>
            <a:off x="895350" y="592438"/>
            <a:ext cx="7791966" cy="579240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-23491" y="6327690"/>
            <a:ext cx="9188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/>
              <a:t>Fig. S2A</a:t>
            </a:r>
          </a:p>
        </p:txBody>
      </p:sp>
    </p:spTree>
    <p:extLst>
      <p:ext uri="{BB962C8B-B14F-4D97-AF65-F5344CB8AC3E}">
        <p14:creationId xmlns:p14="http://schemas.microsoft.com/office/powerpoint/2010/main" val="2642256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/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6" t="8207" r="2633" b="1873"/>
          <a:stretch/>
        </p:blipFill>
        <p:spPr>
          <a:xfrm>
            <a:off x="1066800" y="550016"/>
            <a:ext cx="7584474" cy="5637630"/>
          </a:xfrm>
        </p:spPr>
      </p:pic>
      <p:sp>
        <p:nvSpPr>
          <p:cNvPr id="2" name="Rectangle 1"/>
          <p:cNvSpPr/>
          <p:nvPr/>
        </p:nvSpPr>
        <p:spPr>
          <a:xfrm>
            <a:off x="0" y="6320996"/>
            <a:ext cx="9108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/>
              <a:t>Fig. S2B</a:t>
            </a:r>
          </a:p>
        </p:txBody>
      </p:sp>
    </p:spTree>
    <p:extLst>
      <p:ext uri="{BB962C8B-B14F-4D97-AF65-F5344CB8AC3E}">
        <p14:creationId xmlns:p14="http://schemas.microsoft.com/office/powerpoint/2010/main" val="24204211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4" t="8291" r="3097" b="1893"/>
          <a:stretch/>
        </p:blipFill>
        <p:spPr>
          <a:xfrm>
            <a:off x="838200" y="649408"/>
            <a:ext cx="7644198" cy="5684976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0" y="6334384"/>
            <a:ext cx="9092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/>
              <a:t>Fig. S2C</a:t>
            </a:r>
          </a:p>
        </p:txBody>
      </p:sp>
    </p:spTree>
    <p:extLst>
      <p:ext uri="{BB962C8B-B14F-4D97-AF65-F5344CB8AC3E}">
        <p14:creationId xmlns:p14="http://schemas.microsoft.com/office/powerpoint/2010/main" val="22156083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1" t="8391" r="2496" b="1989"/>
          <a:stretch/>
        </p:blipFill>
        <p:spPr>
          <a:xfrm>
            <a:off x="696097" y="539510"/>
            <a:ext cx="7838303" cy="5800534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0" y="6340044"/>
            <a:ext cx="9188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/>
              <a:t>Fig. S3A</a:t>
            </a:r>
          </a:p>
        </p:txBody>
      </p:sp>
    </p:spTree>
    <p:extLst>
      <p:ext uri="{BB962C8B-B14F-4D97-AF65-F5344CB8AC3E}">
        <p14:creationId xmlns:p14="http://schemas.microsoft.com/office/powerpoint/2010/main" val="5187158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4" t="8429" r="2684" b="1717"/>
          <a:stretch/>
        </p:blipFill>
        <p:spPr>
          <a:xfrm>
            <a:off x="761999" y="462380"/>
            <a:ext cx="7959531" cy="5919370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0" y="6381750"/>
            <a:ext cx="9108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/>
              <a:t>Fig. S3B</a:t>
            </a:r>
          </a:p>
        </p:txBody>
      </p:sp>
    </p:spTree>
    <p:extLst>
      <p:ext uri="{BB962C8B-B14F-4D97-AF65-F5344CB8AC3E}">
        <p14:creationId xmlns:p14="http://schemas.microsoft.com/office/powerpoint/2010/main" val="36490905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1" t="8063" r="2807" b="1797"/>
          <a:stretch/>
        </p:blipFill>
        <p:spPr>
          <a:xfrm>
            <a:off x="952500" y="436867"/>
            <a:ext cx="7830065" cy="5821314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0" y="6372481"/>
            <a:ext cx="9092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>
              <a:defRPr/>
            </a:pPr>
            <a:r>
              <a:rPr lang="en-CA" dirty="0"/>
              <a:t>Fig. S3C</a:t>
            </a:r>
          </a:p>
        </p:txBody>
      </p:sp>
    </p:spTree>
    <p:extLst>
      <p:ext uri="{BB962C8B-B14F-4D97-AF65-F5344CB8AC3E}">
        <p14:creationId xmlns:p14="http://schemas.microsoft.com/office/powerpoint/2010/main" val="36059232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9" t="8859" r="2298" b="1989"/>
          <a:stretch/>
        </p:blipFill>
        <p:spPr>
          <a:xfrm>
            <a:off x="836141" y="477874"/>
            <a:ext cx="7890532" cy="5808626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0" y="6362700"/>
            <a:ext cx="9188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>
              <a:defRPr/>
            </a:pPr>
            <a:r>
              <a:rPr lang="en-CA" dirty="0"/>
              <a:t>Fig. S4A</a:t>
            </a:r>
          </a:p>
        </p:txBody>
      </p:sp>
    </p:spTree>
    <p:extLst>
      <p:ext uri="{BB962C8B-B14F-4D97-AF65-F5344CB8AC3E}">
        <p14:creationId xmlns:p14="http://schemas.microsoft.com/office/powerpoint/2010/main" val="147517345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6" t="8218" r="2891" b="1735"/>
          <a:stretch/>
        </p:blipFill>
        <p:spPr>
          <a:xfrm>
            <a:off x="819665" y="272630"/>
            <a:ext cx="7760455" cy="5770237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0" y="6290517"/>
            <a:ext cx="9108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defTabSz="914400">
              <a:defRPr/>
            </a:pPr>
            <a:r>
              <a:rPr lang="en-CA" dirty="0"/>
              <a:t>Fig. S4B</a:t>
            </a:r>
          </a:p>
        </p:txBody>
      </p:sp>
    </p:spTree>
    <p:extLst>
      <p:ext uri="{BB962C8B-B14F-4D97-AF65-F5344CB8AC3E}">
        <p14:creationId xmlns:p14="http://schemas.microsoft.com/office/powerpoint/2010/main" val="4852576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9</TotalTime>
  <Words>63</Words>
  <Application>Microsoft Office PowerPoint</Application>
  <PresentationFormat>On-screen Show (4:3)</PresentationFormat>
  <Paragraphs>26</Paragraphs>
  <Slides>11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AFC-AA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yissa, Biruk</dc:creator>
  <cp:lastModifiedBy>biruk F</cp:lastModifiedBy>
  <cp:revision>38</cp:revision>
  <dcterms:created xsi:type="dcterms:W3CDTF">2019-08-23T18:42:10Z</dcterms:created>
  <dcterms:modified xsi:type="dcterms:W3CDTF">2020-09-02T18:22:20Z</dcterms:modified>
</cp:coreProperties>
</file>